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6"/>
  </p:normalViewPr>
  <p:slideViewPr>
    <p:cSldViewPr snapToGrid="0" snapToObjects="1">
      <p:cViewPr varScale="1">
        <p:scale>
          <a:sx n="46" d="100"/>
          <a:sy n="46" d="100"/>
        </p:scale>
        <p:origin x="200" y="1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61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3382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7037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7813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6775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9891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91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451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69119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336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3473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9119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981" y="644235"/>
            <a:ext cx="3529730" cy="256120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9928" y="644236"/>
            <a:ext cx="3938662" cy="2604252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908" y="3545608"/>
            <a:ext cx="6133982" cy="2797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738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048000" y="2828836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  <a:spcAft>
                <a:spcPts val="600"/>
              </a:spcAft>
            </a:pP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Fig S2. The rat NASH model was established. (A-B) 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Liver triglyceride and serum insulin levels were detected.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(C)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 Fibrotic deposition was determined by Masson staining. </a:t>
            </a:r>
            <a:r>
              <a:rPr lang="en-US" altLang="zh-CN" kern="10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*P &lt; 0.05, **P &lt; 0.01.</a:t>
            </a:r>
            <a:endParaRPr lang="zh-CN" altLang="zh-CN" kern="100">
              <a:latin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6794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Macintosh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DengXian</vt:lpstr>
      <vt:lpstr>DengXian Light</vt:lpstr>
      <vt:lpstr>Times New Roman</vt:lpstr>
      <vt:lpstr>Arial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3</cp:revision>
  <dcterms:created xsi:type="dcterms:W3CDTF">2022-04-27T13:22:10Z</dcterms:created>
  <dcterms:modified xsi:type="dcterms:W3CDTF">2022-04-28T01:08:57Z</dcterms:modified>
</cp:coreProperties>
</file>